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142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160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847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1924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182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068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101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689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42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89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99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704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C1CB14-C0F7-4486-A44E-75822D18992F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473C82-0ABC-46A5-9FE3-4D8C117DC9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222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7A22B9A-D217-C694-E0EB-FF99ED1E014B}"/>
              </a:ext>
            </a:extLst>
          </p:cNvPr>
          <p:cNvSpPr txBox="1"/>
          <p:nvPr/>
        </p:nvSpPr>
        <p:spPr>
          <a:xfrm>
            <a:off x="0" y="78060"/>
            <a:ext cx="3233275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194"/>
            <a:r>
              <a:rPr lang="en-US" sz="1401" dirty="0">
                <a:solidFill>
                  <a:prstClr val="black"/>
                </a:solidFill>
                <a:latin typeface="Calibri" panose="020F0502020204030204"/>
              </a:rPr>
              <a:t>Supplementary Figure 4, Harrington et al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36AF1FC-71DB-F694-3369-0FEDAB8B9C40}"/>
              </a:ext>
            </a:extLst>
          </p:cNvPr>
          <p:cNvSpPr txBox="1"/>
          <p:nvPr/>
        </p:nvSpPr>
        <p:spPr>
          <a:xfrm>
            <a:off x="160797" y="606043"/>
            <a:ext cx="423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3AE086E-F68E-61F1-EF6D-4A59A41FEE90}"/>
              </a:ext>
            </a:extLst>
          </p:cNvPr>
          <p:cNvSpPr txBox="1"/>
          <p:nvPr/>
        </p:nvSpPr>
        <p:spPr>
          <a:xfrm>
            <a:off x="1799075" y="606043"/>
            <a:ext cx="423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F3CE007-61BA-3A79-1BC2-C5C2B5DCD18C}"/>
              </a:ext>
            </a:extLst>
          </p:cNvPr>
          <p:cNvSpPr txBox="1"/>
          <p:nvPr/>
        </p:nvSpPr>
        <p:spPr>
          <a:xfrm>
            <a:off x="3463187" y="573780"/>
            <a:ext cx="423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723FA09-F3F4-C640-8BF0-DC2B48A171C7}"/>
              </a:ext>
            </a:extLst>
          </p:cNvPr>
          <p:cNvSpPr txBox="1"/>
          <p:nvPr/>
        </p:nvSpPr>
        <p:spPr>
          <a:xfrm>
            <a:off x="4860590" y="573780"/>
            <a:ext cx="423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15D9AD9-8AC9-7E9E-65EC-F9FAEB350D11}"/>
              </a:ext>
            </a:extLst>
          </p:cNvPr>
          <p:cNvSpPr txBox="1"/>
          <p:nvPr/>
        </p:nvSpPr>
        <p:spPr>
          <a:xfrm>
            <a:off x="160797" y="2853455"/>
            <a:ext cx="423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B7475D-86DC-805A-EA08-C736969033AA}"/>
              </a:ext>
            </a:extLst>
          </p:cNvPr>
          <p:cNvSpPr txBox="1"/>
          <p:nvPr/>
        </p:nvSpPr>
        <p:spPr>
          <a:xfrm>
            <a:off x="1799075" y="2853455"/>
            <a:ext cx="423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470EC60-3CCB-9A1A-3BDA-2E775D90C027}"/>
              </a:ext>
            </a:extLst>
          </p:cNvPr>
          <p:cNvSpPr txBox="1"/>
          <p:nvPr/>
        </p:nvSpPr>
        <p:spPr>
          <a:xfrm>
            <a:off x="3463187" y="2821192"/>
            <a:ext cx="423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DB1614A-1908-AB1F-038F-6F93099100F9}"/>
              </a:ext>
            </a:extLst>
          </p:cNvPr>
          <p:cNvSpPr txBox="1"/>
          <p:nvPr/>
        </p:nvSpPr>
        <p:spPr>
          <a:xfrm>
            <a:off x="4860590" y="2821192"/>
            <a:ext cx="4230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H</a:t>
            </a:r>
          </a:p>
        </p:txBody>
      </p:sp>
      <p:pic>
        <p:nvPicPr>
          <p:cNvPr id="18" name="Picture 17" descr="A picture containing light, dark&#10;&#10;Description automatically generated">
            <a:extLst>
              <a:ext uri="{FF2B5EF4-FFF2-40B4-BE49-F238E27FC236}">
                <a16:creationId xmlns:a16="http://schemas.microsoft.com/office/drawing/2014/main" id="{50985C96-FB8D-16CD-4439-D4C247B406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797" y="828896"/>
            <a:ext cx="1740955" cy="208653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AAC94317-2944-EFEF-F9E3-B43104506D1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9693" y="819427"/>
            <a:ext cx="1550774" cy="2086537"/>
          </a:xfrm>
          <a:prstGeom prst="rect">
            <a:avLst/>
          </a:prstGeom>
        </p:spPr>
      </p:pic>
      <p:pic>
        <p:nvPicPr>
          <p:cNvPr id="22" name="Picture 21" descr="A picture containing dark, night sky&#10;&#10;Description automatically generated">
            <a:extLst>
              <a:ext uri="{FF2B5EF4-FFF2-40B4-BE49-F238E27FC236}">
                <a16:creationId xmlns:a16="http://schemas.microsoft.com/office/drawing/2014/main" id="{35D911CF-9C29-AF68-BFD0-56B2889A2FB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0467" y="2896495"/>
            <a:ext cx="1630106" cy="2082370"/>
          </a:xfrm>
          <a:prstGeom prst="rect">
            <a:avLst/>
          </a:prstGeom>
        </p:spPr>
      </p:pic>
      <p:pic>
        <p:nvPicPr>
          <p:cNvPr id="24" name="Picture 23" descr="A picture containing dark, night sky&#10;&#10;Description automatically generated">
            <a:extLst>
              <a:ext uri="{FF2B5EF4-FFF2-40B4-BE49-F238E27FC236}">
                <a16:creationId xmlns:a16="http://schemas.microsoft.com/office/drawing/2014/main" id="{352F2A15-1307-BB91-A388-C2C17ACC24A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7771" y="2896495"/>
            <a:ext cx="1629019" cy="2082370"/>
          </a:xfrm>
          <a:prstGeom prst="rect">
            <a:avLst/>
          </a:prstGeom>
        </p:spPr>
      </p:pic>
      <p:pic>
        <p:nvPicPr>
          <p:cNvPr id="26" name="Picture 25" descr="A picture containing dark, night, night sky&#10;&#10;Description automatically generated">
            <a:extLst>
              <a:ext uri="{FF2B5EF4-FFF2-40B4-BE49-F238E27FC236}">
                <a16:creationId xmlns:a16="http://schemas.microsoft.com/office/drawing/2014/main" id="{407572E1-5C86-73E7-FD30-C0694841203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48315" y="819427"/>
            <a:ext cx="1740955" cy="2086537"/>
          </a:xfrm>
          <a:prstGeom prst="rect">
            <a:avLst/>
          </a:prstGeom>
        </p:spPr>
      </p:pic>
      <p:pic>
        <p:nvPicPr>
          <p:cNvPr id="28" name="Picture 27" descr="A picture containing dark, night sky&#10;&#10;Description automatically generated">
            <a:extLst>
              <a:ext uri="{FF2B5EF4-FFF2-40B4-BE49-F238E27FC236}">
                <a16:creationId xmlns:a16="http://schemas.microsoft.com/office/drawing/2014/main" id="{F4ED51F1-A8D4-7E1E-2B97-3E206AF68F5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6926" y="809958"/>
            <a:ext cx="1550774" cy="2086537"/>
          </a:xfrm>
          <a:prstGeom prst="rect">
            <a:avLst/>
          </a:prstGeom>
        </p:spPr>
      </p:pic>
      <p:pic>
        <p:nvPicPr>
          <p:cNvPr id="30" name="Picture 29" descr="A picture containing dark, night, night sky&#10;&#10;Description automatically generated">
            <a:extLst>
              <a:ext uri="{FF2B5EF4-FFF2-40B4-BE49-F238E27FC236}">
                <a16:creationId xmlns:a16="http://schemas.microsoft.com/office/drawing/2014/main" id="{4144AE54-3D46-89D4-5DBA-1B53FD40EB39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162" y="2901797"/>
            <a:ext cx="1630107" cy="2086537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C1ECC53E-5236-F965-7C8B-67337EB01AF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3427" y="2905964"/>
            <a:ext cx="1687587" cy="208237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E123D76-4B3A-58A9-971A-C6AC602E75B1}"/>
              </a:ext>
            </a:extLst>
          </p:cNvPr>
          <p:cNvSpPr txBox="1"/>
          <p:nvPr/>
        </p:nvSpPr>
        <p:spPr>
          <a:xfrm>
            <a:off x="247227" y="5068604"/>
            <a:ext cx="6126480" cy="193899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4: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alysis of immune cells and macrophages in ACI23 xenografts UGDH overexpression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verX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or vector control (VC). A) Number of CD45+ cells per mm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,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) Percentage of CD45+ immune cells. C) Number of Iba1+ cells per mm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,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) Percentage of Iba1+ immune cells. E) Number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OS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 cells per mm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,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) Percentage of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OS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 immune cells. G) Number of CD206+ cells per mm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,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) Percentage of CD206+ immune cells. *p&lt;0.05, **p&lt;0.01, ***p&lt;0.001.</a:t>
            </a:r>
          </a:p>
        </p:txBody>
      </p:sp>
    </p:spTree>
    <p:extLst>
      <p:ext uri="{BB962C8B-B14F-4D97-AF65-F5344CB8AC3E}">
        <p14:creationId xmlns:p14="http://schemas.microsoft.com/office/powerpoint/2010/main" val="2439811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5</TotalTime>
  <Words>130</Words>
  <Application>Microsoft Office PowerPoint</Application>
  <PresentationFormat>Letter Paper (8.5x11 in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ington, Brittney (NIH/NCI) [F]</dc:creator>
  <cp:lastModifiedBy>Harrington, Brittney (NIH/NCI) [F]</cp:lastModifiedBy>
  <cp:revision>3</cp:revision>
  <dcterms:created xsi:type="dcterms:W3CDTF">2023-08-14T16:44:01Z</dcterms:created>
  <dcterms:modified xsi:type="dcterms:W3CDTF">2023-08-17T17:51:18Z</dcterms:modified>
</cp:coreProperties>
</file>